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5" d="100"/>
          <a:sy n="75" d="100"/>
        </p:scale>
        <p:origin x="874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232D3-61E5-486E-A49E-F2E9E060B8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23B7C0-D605-4C80-841A-2C602A0C92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A9254-C390-4F43-AF86-254EEAB92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295EB-B000-4632-B77D-175FA6ECF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B406D-26AC-4EE0-A179-C0CBDE07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41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D13551-2D4B-49A8-B63A-54816F128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4E0E5F-BEF6-471F-9A3A-BB99D82EC9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434FE-C648-4339-9FC1-E9CA57C78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7B077-246F-4213-A9EE-39D3FEDAC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828C33-D1C8-463C-B3EA-D70766C20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607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73DA6E-0C33-441C-A7DF-7E92517C11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CA0E21-8CD5-4CC2-9E98-395C325C38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C6E9C-B3DB-46FD-A155-42050A981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57902C-C796-4FB0-A2D3-704F378F6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6B02C-3DD6-4D16-9179-C50C5DD3C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92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B51A1-F537-431E-85E9-6225DE852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D30AB3-F987-4F97-8F92-619EAFD894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2C4F9C-2C89-480C-82D0-FAE2A0DAD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078C7-0556-4553-827D-D80CE051D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511CC-6947-4DF0-9E4F-98640CB9C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717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CA6526-847B-4BCD-A533-E603BEC45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02C3FC-4FE2-4E43-8718-D6061F3775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7A189-CB13-4085-8D3E-CC6F53CF5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807426-32F9-4C1E-B735-5E0BAC743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CDAD62-03F4-4CAD-9AC2-9912F5279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147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5A24B-5B16-477E-89DD-F0F0377AE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FB5BF4-7453-4653-87B5-B6A23F2929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AB3A2E-1B16-42E6-8FDB-B1B2614C65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E809B9-758D-4C81-93E9-50DCD2E3B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EC1260-1423-4FD8-B35B-FC6767757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3A3A47-804E-415A-95BE-1C3D884B1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89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4D7D7-3EA8-4A5E-82DB-00FC9F8A4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46F500-1C24-4AEC-8DFE-78AB81D8B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147915-B1D5-4BAC-A15F-7A03FA388B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CE5891-5C76-4A4C-828D-FFA6DDC15C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B09D8F-5FB3-41C2-A2A8-21D8105455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386E79-C3CB-4DDF-B458-5379B8CDF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14FD45-AF72-4D50-A5BB-82AC7F9C8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7DB905-A03F-49E1-9B5A-B48049ECE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233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CD263-E15A-4937-81CF-5F5CB416F7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04D0E3-6DEE-493A-AD15-A172D1286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59DBFF-3275-4A21-A21B-C98C5921D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E938F9-9337-409A-945C-CA96CEE6D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0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94BB8B-E1A9-4A3E-B759-E3CEA9711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0B7E77-138D-4408-BE4D-355E67A49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CB5147-D84A-47AE-95AD-A40AB94CD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549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F32818-02B5-452C-A370-F3C4D3DC8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95075C-659D-4343-AAE9-55CECFCD45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838CF-AC8B-4485-A0DF-13189DF755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F59971-A250-480E-BF5D-9410C2ADA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97D1B-0F27-44F8-A53E-9CD836669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0714E-B3D4-47E9-83B6-B197E77CF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53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757E5-48EF-4B1F-A8D3-5C0F1B9F10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82D430-A695-4D84-B557-470F69F233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22EF48-3BE8-413F-8F73-492A987D8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5A7232-2EAA-403A-91B7-AE0FB8845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416A8-F4E4-41A3-B8F4-4A9413925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C17A5-6180-4E07-B681-E7131680F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42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8FE2029-8F42-41CA-9DB9-2DC1314C1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77AF25-864B-45FC-85FD-82F8414E92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12A3D-1EB6-4C64-9D34-9ADDB0A312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29A29-C0C1-4970-8CFA-9102BDA0BFE4}" type="datetimeFigureOut">
              <a:rPr lang="en-US" smtClean="0"/>
              <a:t>8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5E18-81AE-4F66-97A7-8AF72CF24E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B6C0D-A539-4A76-A6D6-67024BA1D0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EE851-E5F8-4154-8383-CA6A8DEE37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157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93BDAAC-6CEA-4CB7-93D7-13A1FB491D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36819"/>
            <a:ext cx="12192000" cy="551588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EBB1522-FBC4-47EA-B2E5-A32D1C1888E7}"/>
              </a:ext>
            </a:extLst>
          </p:cNvPr>
          <p:cNvSpPr txBox="1"/>
          <p:nvPr/>
        </p:nvSpPr>
        <p:spPr>
          <a:xfrm>
            <a:off x="441960" y="305300"/>
            <a:ext cx="11308080" cy="477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PI networks based on the hub genes of the eight candidate modules. Large circles and orange octagons represent hub-hub genes and TFs, respectively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248D1A3-F813-42C7-A3E8-FD2C8857B82D}"/>
              </a:ext>
            </a:extLst>
          </p:cNvPr>
          <p:cNvSpPr/>
          <p:nvPr/>
        </p:nvSpPr>
        <p:spPr>
          <a:xfrm>
            <a:off x="321855" y="6272430"/>
            <a:ext cx="2618024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urquoise module (identified by MTRs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41927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2A79B5A-2B53-46DF-8F8E-309310FA96A0}"/>
              </a:ext>
            </a:extLst>
          </p:cNvPr>
          <p:cNvSpPr/>
          <p:nvPr/>
        </p:nvSpPr>
        <p:spPr>
          <a:xfrm>
            <a:off x="537016" y="6272009"/>
            <a:ext cx="2438488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urple module (identified by MTRs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BDC154A-DCCD-49D3-ABB5-E99973110A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5721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6039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E33F7FE-EE42-4754-8B45-0683E64AA719}"/>
              </a:ext>
            </a:extLst>
          </p:cNvPr>
          <p:cNvSpPr/>
          <p:nvPr/>
        </p:nvSpPr>
        <p:spPr>
          <a:xfrm>
            <a:off x="516439" y="6186940"/>
            <a:ext cx="2138727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ue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C6A1C54-101D-48C0-9C35-B9C7FDF41A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41134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F91B3A2-3CF2-41BC-AF43-485A33FDD37A}"/>
              </a:ext>
            </a:extLst>
          </p:cNvPr>
          <p:cNvSpPr/>
          <p:nvPr/>
        </p:nvSpPr>
        <p:spPr>
          <a:xfrm>
            <a:off x="314111" y="6137562"/>
            <a:ext cx="2635658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eenyellow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F58D4CC-BF12-4786-BAFB-7CFAE49B31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16436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3DF1401-33BC-419D-AA63-8CB5631833BC}"/>
              </a:ext>
            </a:extLst>
          </p:cNvPr>
          <p:cNvSpPr/>
          <p:nvPr/>
        </p:nvSpPr>
        <p:spPr>
          <a:xfrm>
            <a:off x="429133" y="6251380"/>
            <a:ext cx="2266967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urple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305C439-DB5A-4DC3-AA99-F84E1875AC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8153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53D54DBA-916E-4CD7-BB58-18EDB34D5CA1}"/>
              </a:ext>
            </a:extLst>
          </p:cNvPr>
          <p:cNvSpPr/>
          <p:nvPr/>
        </p:nvSpPr>
        <p:spPr>
          <a:xfrm>
            <a:off x="530310" y="6100909"/>
            <a:ext cx="2069797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DEA70D5-321D-4CDE-A893-DBA9B7A18B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08102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7E65CA1-9E1F-45D2-A3C6-01D8E6351CD2}"/>
              </a:ext>
            </a:extLst>
          </p:cNvPr>
          <p:cNvSpPr/>
          <p:nvPr/>
        </p:nvSpPr>
        <p:spPr>
          <a:xfrm>
            <a:off x="668454" y="6112483"/>
            <a:ext cx="2318263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lmon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697C656-E4E1-4524-9D0D-FA45BD7F5A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0160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7490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A105935-92F1-4A68-8EFB-DF4881592CCA}"/>
              </a:ext>
            </a:extLst>
          </p:cNvPr>
          <p:cNvSpPr/>
          <p:nvPr/>
        </p:nvSpPr>
        <p:spPr>
          <a:xfrm>
            <a:off x="641391" y="6239806"/>
            <a:ext cx="2292615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yellow module (identified by MP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FC1A994-3582-4C39-A1E4-82864D561A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059"/>
            <a:ext cx="12192000" cy="5515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3288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6</Words>
  <Application>Microsoft Office PowerPoint</Application>
  <PresentationFormat>Widescreen</PresentationFormat>
  <Paragraphs>9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akbar_H</dc:creator>
  <cp:lastModifiedBy>Aliakbar_H</cp:lastModifiedBy>
  <cp:revision>8</cp:revision>
  <dcterms:created xsi:type="dcterms:W3CDTF">2021-08-04T16:00:08Z</dcterms:created>
  <dcterms:modified xsi:type="dcterms:W3CDTF">2021-08-04T16:16:27Z</dcterms:modified>
</cp:coreProperties>
</file>